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3686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1735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2582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5061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4814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56218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2379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47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725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2028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9800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615A65-B5B7-48FF-A0BE-3D6CBF718C6D}" type="datetimeFigureOut">
              <a:rPr lang="ko-KR" altLang="en-US" smtClean="0"/>
              <a:t>2018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15E81D-B7DA-45CA-BA1A-EA5775435F1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49899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10735" y="2750708"/>
            <a:ext cx="30938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800" b="1" dirty="0" smtClean="0">
                <a:latin typeface="Arial"/>
                <a:cs typeface="Arial"/>
              </a:rPr>
              <a:t>Rab35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060782" y="3072918"/>
            <a:ext cx="259333" cy="1182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sz="800" b="1" dirty="0" smtClean="0">
                <a:latin typeface="Arial"/>
                <a:cs typeface="Arial"/>
              </a:rPr>
              <a:t>Actin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 rot="18900000">
            <a:off x="2342895" y="2289430"/>
            <a:ext cx="69730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lfactory bul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8900000">
            <a:off x="2694208" y="2408447"/>
            <a:ext cx="325410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900000">
            <a:off x="2923936" y="2283196"/>
            <a:ext cx="679673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ppocampus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8900000">
            <a:off x="3266703" y="2375342"/>
            <a:ext cx="41678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iatum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8900000">
            <a:off x="3510142" y="2234555"/>
            <a:ext cx="812723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entral midbrain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8900000">
            <a:off x="3828610" y="2325137"/>
            <a:ext cx="561051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8900000">
            <a:off x="4117213" y="2347806"/>
            <a:ext cx="532197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rain stem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059" t="42264" r="37706" b="55038"/>
          <a:stretch/>
        </p:blipFill>
        <p:spPr>
          <a:xfrm>
            <a:off x="2393934" y="2984372"/>
            <a:ext cx="2003505" cy="26266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372" t="31315" r="37049" b="66463"/>
          <a:stretch/>
        </p:blipFill>
        <p:spPr>
          <a:xfrm>
            <a:off x="2393934" y="2675326"/>
            <a:ext cx="2003505" cy="25435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5" name="TextBox 22"/>
          <p:cNvSpPr txBox="1"/>
          <p:nvPr/>
        </p:nvSpPr>
        <p:spPr>
          <a:xfrm>
            <a:off x="293232" y="1226629"/>
            <a:ext cx="6220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4. Expression of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b35 in adult mouse brain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6511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</Words>
  <Application>Microsoft Office PowerPoint</Application>
  <PresentationFormat>A4 용지(210x297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1</cp:revision>
  <dcterms:created xsi:type="dcterms:W3CDTF">2018-01-05T11:16:33Z</dcterms:created>
  <dcterms:modified xsi:type="dcterms:W3CDTF">2018-01-05T11:17:07Z</dcterms:modified>
</cp:coreProperties>
</file>